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67F7368-1574-4360-93D8-0FD106ABC96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628560" y="182520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8C18846-4AAF-4538-B697-65DEF97A785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60CC5CF-05CB-4206-869D-9836CD148CD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62856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329544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596232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62856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329544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596232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F702A23-0A79-4D62-B7D6-C50ABF1400C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628560" y="1825200"/>
            <a:ext cx="788688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6F44F58-3398-4B94-8CB3-DCE82CA0747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628560" y="1825200"/>
            <a:ext cx="788688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B37FE34-2A62-4649-8FE0-E2D81EF3459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83F07BB-A0F3-49C3-93B6-E92BC7F3CAF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E537E79-5DCF-4536-A488-E941250EE5D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28560" y="365040"/>
            <a:ext cx="788688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BBF85DC-2754-4178-BBC8-9F165699A81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C66D9FA-C0BE-4204-A442-0F829617E3D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B3CEA1-9259-4CA3-BDF8-6E3374D0D0B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F9D076C-E8B9-4E73-AE09-7CF5B98BEB4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628560" y="1825200"/>
            <a:ext cx="788688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628200" y="6356520"/>
            <a:ext cx="20574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029040" y="6356520"/>
            <a:ext cx="308592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457680" y="6356520"/>
            <a:ext cx="20574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4DDA41B-4112-4762-9D51-C187E6E348A3}" type="slidenum">
              <a:rPr b="0" lang="ko-KR"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그림 3" descr=""/>
          <p:cNvPicPr/>
          <p:nvPr/>
        </p:nvPicPr>
        <p:blipFill>
          <a:blip r:embed="rId1"/>
          <a:stretch/>
        </p:blipFill>
        <p:spPr>
          <a:xfrm>
            <a:off x="487440" y="473040"/>
            <a:ext cx="2682720" cy="2427480"/>
          </a:xfrm>
          <a:prstGeom prst="rect">
            <a:avLst/>
          </a:prstGeom>
          <a:ln w="0">
            <a:noFill/>
          </a:ln>
        </p:spPr>
      </p:pic>
      <p:sp>
        <p:nvSpPr>
          <p:cNvPr id="42" name="직사각형 4"/>
          <p:cNvSpPr/>
          <p:nvPr/>
        </p:nvSpPr>
        <p:spPr>
          <a:xfrm>
            <a:off x="274680" y="5167440"/>
            <a:ext cx="7954920" cy="1739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한양신명조,한컴돋움"/>
              </a:rPr>
              <a:t>Additional file 2: Figure S2. </a:t>
            </a:r>
            <a:r>
              <a:rPr b="0" lang="en-US" sz="1800" spc="-1" strike="noStrike">
                <a:solidFill>
                  <a:srgbClr val="000000"/>
                </a:solidFill>
                <a:latin typeface="Times New Roman"/>
                <a:ea typeface="한양신명조,한컴돋움"/>
              </a:rPr>
              <a:t>SDS-PAGE of supernatant after ASC cultivation.  Comparison of protein composition of con sup (concentrated medium for ASCs cultivation) and ASC sup (concentrated culture supernatant after ASC cultivation for three days) using SDS-PAGE. Thirty micrograms of each sample was loaded into an SDS-PAGE gel. After electrophoresis, the gel was stained by Coomassie Blue (M; molecular marker, arrow indicated extra proteins compare to control).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0-01T03:24:14Z</dcterms:created>
  <dc:creator>Hak Sun Yu</dc:creator>
  <dc:description/>
  <dc:language>en-US</dc:language>
  <cp:lastModifiedBy>para</cp:lastModifiedBy>
  <dcterms:modified xsi:type="dcterms:W3CDTF">2016-12-30T01:57:24Z</dcterms:modified>
  <cp:revision>5</cp:revision>
  <dc:subject/>
  <dc:title>PowerPoint 프레젠테이션</dc:title>
</cp:coreProperties>
</file>